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73" r:id="rId3"/>
    <p:sldId id="274" r:id="rId4"/>
    <p:sldId id="262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2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2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EF3083-C44F-67B7-3E5F-C695075B23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36720C-9405-469C-876D-FD49834A3D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F555F6-D0F1-33A9-E4E1-9D3C12519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C53278-84C5-A99F-84DE-2C7B0F673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BBFDC6-2EDE-34A9-A252-F848A1FFB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375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7295D-E1AC-E372-8EF5-E40BA111D2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9BAF42-B142-735B-9E3F-B74460CA5B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13C2B-6E46-71B0-933E-9F1572F2A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13F96F-933D-1F6C-9F53-1AA67632A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F9F7B4-0A0B-59F7-30FC-5318B4329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54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E80F36-F39A-A950-1F69-274E1A9370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80A9CC-49C3-3F88-CDAA-60D91E7840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1288C-B53A-40BB-814A-B1305BB4AC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07D13-278B-BCA5-A735-E4DE2A26D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62708B-4640-E930-FF58-3CD2CE615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275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DE185-9D25-844E-DC97-4BE92DCBB2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E1655E-A85B-4F42-737C-81A32F99B3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B65FA0-8849-CB96-8F89-C9B75DB25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7ED62E-2F2C-5BE6-3F35-C4348D16F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F838E6-7419-B0DF-41E9-AEF3CD7E0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922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293B51-8B8A-BA85-A2D0-3E55297B9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3CB87F-BF83-823B-F582-42E7F0255B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C22411-044B-A831-DC55-939C5C760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8AF60B-3E2B-E62E-38CA-EDF1EA3FC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B4C094-B27B-5543-0F69-6C315850B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253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F694A-3032-6AFB-5286-9C014E49A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221191-A6A5-99AF-4561-7C30F8509B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A6E06B-5AFA-2E06-4B87-EBD506FEDF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8C5882-9129-25E0-A149-87B043D87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36F7A5-5409-D72B-CB12-E69F2CF0D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D3204A-0C6A-14E2-6394-9A588649C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762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B3A84B-07E0-5315-5548-2601767C6E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B68A50-B691-4B1D-7F06-84F1C9C49C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C28D20-49E6-435D-8F9C-F56E98D501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FA47CF-1314-2041-EEE6-5313E44DAA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67C8C9-7516-BD3D-4613-EFCF39B5BB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FAF706-046B-FE96-AC0F-C020BB12E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5F76A1F-6170-132F-69E5-0879B487F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8F580E-CAF4-B99A-29AE-26557E97E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274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0E9BC6-585A-981C-C6A2-082172D7EF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40B3FF3-1CA5-F84A-56A5-77C088A9D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698EF27-762F-A6DB-659C-297538CD4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779218-1CAC-F38D-6339-3970DDDE7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080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FA7860-85E1-6B35-167B-E6F22E25E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587CA3-F7E2-89FE-5DC5-35778A55C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8887BA-912B-32E7-8438-A0D6E677F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580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EF3BC-851A-0CC3-51FF-2EBB56F50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10229A-A6FA-B4FA-DAC9-62284B12E1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F03301-C805-1E93-FC8B-645EDA3F16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9814B0-F637-5D50-3798-469DAA22D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437CFA-B40F-4A05-B1AB-3DEE5BD52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DB4C90-4442-2158-3074-D8A755CCD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05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33C0BF-F67B-60E6-415D-05D86CE42B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C04AD5-6416-623B-F248-A4626758D8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29DCD-96ED-4BAF-547E-E3CF40AACB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209E6D-6509-9743-9CC4-671731AE2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05B7FD-EA7B-6879-27D0-242E63FF8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50B57-1523-5FDA-759F-96A8EF134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448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A5053F-16C7-1A66-6DA9-75290DFC90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24D7E9-F341-E93B-534D-C953D7B2C5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686773-9698-151C-675F-6A5868F01B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FA8466-2350-4846-902C-AF66E36EA56F}" type="datetimeFigureOut">
              <a:rPr lang="en-US" smtClean="0"/>
              <a:t>4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53EC2F-C24F-401A-EE9F-3581FBA185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19C6E4-E384-09AE-F322-DF167702F0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152C45-8942-4925-BD57-105998E02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43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C95F6EA0-45FA-6B17-3D1A-C96E491259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6329429"/>
              </p:ext>
            </p:extLst>
          </p:nvPr>
        </p:nvGraphicFramePr>
        <p:xfrm>
          <a:off x="2506412" y="2129715"/>
          <a:ext cx="7179173" cy="227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98145">
                  <a:extLst>
                    <a:ext uri="{9D8B030D-6E8A-4147-A177-3AD203B41FA5}">
                      <a16:colId xmlns:a16="http://schemas.microsoft.com/office/drawing/2014/main" val="2144632260"/>
                    </a:ext>
                  </a:extLst>
                </a:gridCol>
                <a:gridCol w="1172420">
                  <a:extLst>
                    <a:ext uri="{9D8B030D-6E8A-4147-A177-3AD203B41FA5}">
                      <a16:colId xmlns:a16="http://schemas.microsoft.com/office/drawing/2014/main" val="559060443"/>
                    </a:ext>
                  </a:extLst>
                </a:gridCol>
                <a:gridCol w="951128">
                  <a:extLst>
                    <a:ext uri="{9D8B030D-6E8A-4147-A177-3AD203B41FA5}">
                      <a16:colId xmlns:a16="http://schemas.microsoft.com/office/drawing/2014/main" val="179987157"/>
                    </a:ext>
                  </a:extLst>
                </a:gridCol>
                <a:gridCol w="1691403">
                  <a:extLst>
                    <a:ext uri="{9D8B030D-6E8A-4147-A177-3AD203B41FA5}">
                      <a16:colId xmlns:a16="http://schemas.microsoft.com/office/drawing/2014/main" val="4137301121"/>
                    </a:ext>
                  </a:extLst>
                </a:gridCol>
                <a:gridCol w="1392560">
                  <a:extLst>
                    <a:ext uri="{9D8B030D-6E8A-4147-A177-3AD203B41FA5}">
                      <a16:colId xmlns:a16="http://schemas.microsoft.com/office/drawing/2014/main" val="309826055"/>
                    </a:ext>
                  </a:extLst>
                </a:gridCol>
                <a:gridCol w="873517">
                  <a:extLst>
                    <a:ext uri="{9D8B030D-6E8A-4147-A177-3AD203B41FA5}">
                      <a16:colId xmlns:a16="http://schemas.microsoft.com/office/drawing/2014/main" val="676388120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Table S1: Information on the </a:t>
                      </a:r>
                      <a:r>
                        <a:rPr lang="en-US" sz="10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LCO1B1</a:t>
                      </a:r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 gene SNPs, the identifier of the reference SNP (</a:t>
                      </a:r>
                      <a:r>
                        <a:rPr lang="en-US" sz="10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rs</a:t>
                      </a:r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), the activity assignment (star alleles), respective functions, and the minor allele frequency (MAF).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15071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Gene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rs</a:t>
                      </a:r>
                      <a:r>
                        <a:rPr lang="en-US" sz="10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number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NP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Identified star allele(s)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Function 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MAF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03966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LCO1B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rs41490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fr-FR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.521T&gt;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*5, *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poor function, decreased fun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=0.15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9640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LCO1B1</a:t>
                      </a:r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rs110458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.463C&gt;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*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increased fun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A=0.15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11792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LCO1B1</a:t>
                      </a:r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rs23062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.388A&gt;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*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normal fun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G=0.4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28729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SLCO1B1</a:t>
                      </a:r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rs34671512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.1929A&gt;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*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increased fun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=0.0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358243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8579AA2-0EA4-065C-7419-46C1B1D7C567}"/>
              </a:ext>
            </a:extLst>
          </p:cNvPr>
          <p:cNvSpPr txBox="1"/>
          <p:nvPr/>
        </p:nvSpPr>
        <p:spPr>
          <a:xfrm>
            <a:off x="4739601" y="409758"/>
            <a:ext cx="2712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S1</a:t>
            </a:r>
          </a:p>
        </p:txBody>
      </p:sp>
    </p:spTree>
    <p:extLst>
      <p:ext uri="{BB962C8B-B14F-4D97-AF65-F5344CB8AC3E}">
        <p14:creationId xmlns:p14="http://schemas.microsoft.com/office/powerpoint/2010/main" val="994204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57DE0C0-B3B3-BBB2-6402-FE4C7F5AEF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445656"/>
              </p:ext>
            </p:extLst>
          </p:nvPr>
        </p:nvGraphicFramePr>
        <p:xfrm>
          <a:off x="3281082" y="1156053"/>
          <a:ext cx="5504329" cy="4545894"/>
        </p:xfrm>
        <a:graphic>
          <a:graphicData uri="http://schemas.openxmlformats.org/drawingml/2006/table">
            <a:tbl>
              <a:tblPr/>
              <a:tblGrid>
                <a:gridCol w="771401">
                  <a:extLst>
                    <a:ext uri="{9D8B030D-6E8A-4147-A177-3AD203B41FA5}">
                      <a16:colId xmlns:a16="http://schemas.microsoft.com/office/drawing/2014/main" val="1788768691"/>
                    </a:ext>
                  </a:extLst>
                </a:gridCol>
                <a:gridCol w="1030443">
                  <a:extLst>
                    <a:ext uri="{9D8B030D-6E8A-4147-A177-3AD203B41FA5}">
                      <a16:colId xmlns:a16="http://schemas.microsoft.com/office/drawing/2014/main" val="1331453007"/>
                    </a:ext>
                  </a:extLst>
                </a:gridCol>
                <a:gridCol w="1030443">
                  <a:extLst>
                    <a:ext uri="{9D8B030D-6E8A-4147-A177-3AD203B41FA5}">
                      <a16:colId xmlns:a16="http://schemas.microsoft.com/office/drawing/2014/main" val="1903440601"/>
                    </a:ext>
                  </a:extLst>
                </a:gridCol>
                <a:gridCol w="1030443">
                  <a:extLst>
                    <a:ext uri="{9D8B030D-6E8A-4147-A177-3AD203B41FA5}">
                      <a16:colId xmlns:a16="http://schemas.microsoft.com/office/drawing/2014/main" val="1780738096"/>
                    </a:ext>
                  </a:extLst>
                </a:gridCol>
                <a:gridCol w="1641599">
                  <a:extLst>
                    <a:ext uri="{9D8B030D-6E8A-4147-A177-3AD203B41FA5}">
                      <a16:colId xmlns:a16="http://schemas.microsoft.com/office/drawing/2014/main" val="3215136703"/>
                    </a:ext>
                  </a:extLst>
                </a:gridCol>
              </a:tblGrid>
              <a:tr h="0">
                <a:tc gridSpan="5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2: Overview of haplotypes and genotype-predicted phenotypes distribution of the 119 enrolled patients.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8753543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acteristics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scription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lues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756534"/>
                  </a:ext>
                </a:extLst>
              </a:tr>
              <a:tr h="0">
                <a:tc rowSpan="8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plotypes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br>
                        <a:rPr lang="de-CH" sz="1000" dirty="0">
                          <a:effectLst/>
                        </a:rPr>
                      </a:b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pected</a:t>
                      </a: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equency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served</a:t>
                      </a: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equency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i-quadrat </a:t>
                      </a: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st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922703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1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03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29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=0.000000283</a:t>
                      </a:r>
                      <a:r>
                        <a:rPr lang="de-CH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392312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5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0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9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38241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14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6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2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26386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15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50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9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347652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20</a:t>
                      </a: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7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6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916502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37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3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5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32439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  <a:r>
                        <a:rPr lang="de-CH" sz="10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4870040"/>
                  </a:ext>
                </a:extLst>
              </a:tr>
              <a:tr h="0">
                <a:tc rowSpan="6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enotypes</a:t>
                      </a: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br>
                        <a:rPr lang="de-CH" sz="1000">
                          <a:effectLst/>
                        </a:rPr>
                      </a:b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pected</a:t>
                      </a: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equency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served frequency</a:t>
                      </a:r>
                      <a:endParaRPr lang="en-US" sz="1000" noProof="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i-quadrat </a:t>
                      </a:r>
                      <a:r>
                        <a:rPr lang="de-CH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st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556362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1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5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=0.763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974043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83</a:t>
                      </a: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6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37768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56</a:t>
                      </a: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1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582236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1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62797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  <a:r>
                        <a:rPr lang="de-CH" sz="10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</a:t>
                      </a:r>
                      <a:endParaRPr lang="de-CH" sz="100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</a:t>
                      </a: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6809682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: IF = increased function, NF = normal function, DF = decreased function, PF = poor function, a: significant difference, b: combined rare variants OATP1B1*23, *26, *41, c: intermediate and possible decreased phenotypes </a:t>
                      </a:r>
                    </a:p>
                  </a:txBody>
                  <a:tcPr marL="35091" marR="35091" marT="35091" marB="35091" anchor="ctr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653235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09DEE78-8FC0-97B5-C45C-FA48A73CE388}"/>
              </a:ext>
            </a:extLst>
          </p:cNvPr>
          <p:cNvSpPr txBox="1"/>
          <p:nvPr/>
        </p:nvSpPr>
        <p:spPr>
          <a:xfrm>
            <a:off x="4739601" y="409758"/>
            <a:ext cx="2712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S2</a:t>
            </a:r>
          </a:p>
        </p:txBody>
      </p:sp>
    </p:spTree>
    <p:extLst>
      <p:ext uri="{BB962C8B-B14F-4D97-AF65-F5344CB8AC3E}">
        <p14:creationId xmlns:p14="http://schemas.microsoft.com/office/powerpoint/2010/main" val="17630868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57DE0C0-B3B3-BBB2-6402-FE4C7F5AEF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9571333"/>
              </p:ext>
            </p:extLst>
          </p:nvPr>
        </p:nvGraphicFramePr>
        <p:xfrm>
          <a:off x="2853253" y="779090"/>
          <a:ext cx="6485489" cy="5953602"/>
        </p:xfrm>
        <a:graphic>
          <a:graphicData uri="http://schemas.openxmlformats.org/drawingml/2006/table">
            <a:tbl>
              <a:tblPr/>
              <a:tblGrid>
                <a:gridCol w="3025280">
                  <a:extLst>
                    <a:ext uri="{9D8B030D-6E8A-4147-A177-3AD203B41FA5}">
                      <a16:colId xmlns:a16="http://schemas.microsoft.com/office/drawing/2014/main" val="1788768691"/>
                    </a:ext>
                  </a:extLst>
                </a:gridCol>
                <a:gridCol w="3460209">
                  <a:extLst>
                    <a:ext uri="{9D8B030D-6E8A-4147-A177-3AD203B41FA5}">
                      <a16:colId xmlns:a16="http://schemas.microsoft.com/office/drawing/2014/main" val="19034406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3: Overview of numbers of subjects in each subgroup analyzed in this study.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87535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</a:t>
                      </a:r>
                      <a:endParaRPr lang="en-US" sz="1000" noProof="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subjects</a:t>
                      </a:r>
                      <a:endParaRPr lang="en-US" sz="1000" noProof="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B7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7565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noProof="0" dirty="0">
                          <a:effectLst/>
                        </a:rPr>
                        <a:t>Figure 2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o inhibitor: 98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Inhibitor: 24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58252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noProof="0" dirty="0">
                          <a:effectLst/>
                        </a:rPr>
                        <a:t>Figure 3A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PF: 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: 2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: 64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IF: 4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17823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noProof="0" dirty="0">
                          <a:effectLst/>
                        </a:rPr>
                        <a:t>Figure 3B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PF: 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:30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: 79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IF: 5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1774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gure 4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PF no inhibitor: 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no inhibitor: 2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no inhibitor: 64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noProof="0" dirty="0">
                        <a:effectLst/>
                      </a:endParaRP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inhibitor: 8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inhibitor: 1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IF inhibitor: 1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22834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gure 5A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no inhibitor: 2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atorvastatin: 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no inhibitor: 6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atorvastatin: 3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12716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gure 5B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no inhibitor: 2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ezetimibe: 1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42363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gure 5C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no inhibitor: 2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</a:t>
                      </a:r>
                      <a:r>
                        <a:rPr lang="en-US" sz="1000" noProof="0" dirty="0" err="1">
                          <a:effectLst/>
                        </a:rPr>
                        <a:t>semaglutide</a:t>
                      </a:r>
                      <a:r>
                        <a:rPr lang="en-US" sz="1000" noProof="0" dirty="0">
                          <a:effectLst/>
                        </a:rPr>
                        <a:t>: 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no inhibitor: 6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</a:t>
                      </a:r>
                      <a:r>
                        <a:rPr lang="en-US" sz="1000" noProof="0" dirty="0" err="1">
                          <a:effectLst/>
                        </a:rPr>
                        <a:t>semaglutide</a:t>
                      </a:r>
                      <a:r>
                        <a:rPr lang="en-US" sz="1000" noProof="0" dirty="0">
                          <a:effectLst/>
                        </a:rPr>
                        <a:t>: 2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62009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gure 5D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no inhibitor: 2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DF metformin: 1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no inhibitor: 6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noProof="0" dirty="0">
                          <a:effectLst/>
                        </a:rPr>
                        <a:t>NF metformin: 2</a:t>
                      </a: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603612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: IF = increased function, NF = normal function, DF = decreased function, PF = poor function</a:t>
                      </a:r>
                    </a:p>
                  </a:txBody>
                  <a:tcPr marL="35091" marR="35091" marT="35091" marB="35091" anchor="ctr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CH" sz="1000" dirty="0">
                        <a:effectLst/>
                      </a:endParaRPr>
                    </a:p>
                  </a:txBody>
                  <a:tcPr marL="35091" marR="35091" marT="35091" marB="3509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653235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09DEE78-8FC0-97B5-C45C-FA48A73CE388}"/>
              </a:ext>
            </a:extLst>
          </p:cNvPr>
          <p:cNvSpPr txBox="1"/>
          <p:nvPr/>
        </p:nvSpPr>
        <p:spPr>
          <a:xfrm>
            <a:off x="4739601" y="409758"/>
            <a:ext cx="2712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S3</a:t>
            </a:r>
          </a:p>
        </p:txBody>
      </p:sp>
    </p:spTree>
    <p:extLst>
      <p:ext uri="{BB962C8B-B14F-4D97-AF65-F5344CB8AC3E}">
        <p14:creationId xmlns:p14="http://schemas.microsoft.com/office/powerpoint/2010/main" val="16184807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E3EBC75-B934-448C-D065-E86879CB4AD4}"/>
              </a:ext>
            </a:extLst>
          </p:cNvPr>
          <p:cNvSpPr txBox="1"/>
          <p:nvPr/>
        </p:nvSpPr>
        <p:spPr>
          <a:xfrm>
            <a:off x="4739601" y="409758"/>
            <a:ext cx="280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1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99E19AF-F994-9448-375E-5431DC3203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1647947"/>
              </p:ext>
            </p:extLst>
          </p:nvPr>
        </p:nvGraphicFramePr>
        <p:xfrm>
          <a:off x="930222" y="1764586"/>
          <a:ext cx="10331556" cy="33288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320742" imgH="2037031" progId="Prism10.Document">
                  <p:embed/>
                </p:oleObj>
              </mc:Choice>
              <mc:Fallback>
                <p:oleObj name="Prism 10" r:id="rId2" imgW="6320742" imgH="203703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30222" y="1764586"/>
                        <a:ext cx="10331556" cy="33288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41188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0</Words>
  <Application>Microsoft Office PowerPoint</Application>
  <PresentationFormat>Widescreen</PresentationFormat>
  <Paragraphs>131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Company>Universität Base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ila Potzel</dc:creator>
  <cp:lastModifiedBy>Leila Potzel</cp:lastModifiedBy>
  <cp:revision>71</cp:revision>
  <dcterms:created xsi:type="dcterms:W3CDTF">2025-11-12T14:22:48Z</dcterms:created>
  <dcterms:modified xsi:type="dcterms:W3CDTF">2026-04-30T09:49:46Z</dcterms:modified>
</cp:coreProperties>
</file>